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2192000" cy="8423275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43" autoAdjust="0"/>
    <p:restoredTop sz="94660"/>
  </p:normalViewPr>
  <p:slideViewPr>
    <p:cSldViewPr snapToGrid="0">
      <p:cViewPr>
        <p:scale>
          <a:sx n="60" d="100"/>
          <a:sy n="60" d="100"/>
        </p:scale>
        <p:origin x="888" y="-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378532"/>
            <a:ext cx="10363200" cy="2932548"/>
          </a:xfrm>
        </p:spPr>
        <p:txBody>
          <a:bodyPr anchor="b"/>
          <a:lstStyle>
            <a:lvl1pPr algn="ctr">
              <a:defRPr sz="7369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424170"/>
            <a:ext cx="9144000" cy="2033674"/>
          </a:xfrm>
        </p:spPr>
        <p:txBody>
          <a:bodyPr/>
          <a:lstStyle>
            <a:lvl1pPr marL="0" indent="0" algn="ctr">
              <a:buNone/>
              <a:defRPr sz="2948"/>
            </a:lvl1pPr>
            <a:lvl2pPr marL="561533" indent="0" algn="ctr">
              <a:buNone/>
              <a:defRPr sz="2456"/>
            </a:lvl2pPr>
            <a:lvl3pPr marL="1123066" indent="0" algn="ctr">
              <a:buNone/>
              <a:defRPr sz="2211"/>
            </a:lvl3pPr>
            <a:lvl4pPr marL="1684599" indent="0" algn="ctr">
              <a:buNone/>
              <a:defRPr sz="1965"/>
            </a:lvl4pPr>
            <a:lvl5pPr marL="2246132" indent="0" algn="ctr">
              <a:buNone/>
              <a:defRPr sz="1965"/>
            </a:lvl5pPr>
            <a:lvl6pPr marL="2807665" indent="0" algn="ctr">
              <a:buNone/>
              <a:defRPr sz="1965"/>
            </a:lvl6pPr>
            <a:lvl7pPr marL="3369198" indent="0" algn="ctr">
              <a:buNone/>
              <a:defRPr sz="1965"/>
            </a:lvl7pPr>
            <a:lvl8pPr marL="3930731" indent="0" algn="ctr">
              <a:buNone/>
              <a:defRPr sz="1965"/>
            </a:lvl8pPr>
            <a:lvl9pPr marL="4492264" indent="0" algn="ctr">
              <a:buNone/>
              <a:defRPr sz="1965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CF1E-7AA4-4E42-A424-C38EAB80E525}" type="datetimeFigureOut">
              <a:rPr lang="zh-CN" altLang="en-US" smtClean="0"/>
              <a:t>2017/5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D229F9-B25F-451A-B756-CC9285415E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99569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CF1E-7AA4-4E42-A424-C38EAB80E525}" type="datetimeFigureOut">
              <a:rPr lang="zh-CN" altLang="en-US" smtClean="0"/>
              <a:t>2017/5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D229F9-B25F-451A-B756-CC9285415E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82677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48462"/>
            <a:ext cx="2628900" cy="7138336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48462"/>
            <a:ext cx="7734300" cy="7138336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CF1E-7AA4-4E42-A424-C38EAB80E525}" type="datetimeFigureOut">
              <a:rPr lang="zh-CN" altLang="en-US" smtClean="0"/>
              <a:t>2017/5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D229F9-B25F-451A-B756-CC9285415E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25748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CF1E-7AA4-4E42-A424-C38EAB80E525}" type="datetimeFigureOut">
              <a:rPr lang="zh-CN" altLang="en-US" smtClean="0"/>
              <a:t>2017/5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D229F9-B25F-451A-B756-CC9285415E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77470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099972"/>
            <a:ext cx="10515600" cy="3503848"/>
          </a:xfrm>
        </p:spPr>
        <p:txBody>
          <a:bodyPr anchor="b"/>
          <a:lstStyle>
            <a:lvl1pPr>
              <a:defRPr sz="7369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5636967"/>
            <a:ext cx="10515600" cy="1842591"/>
          </a:xfrm>
        </p:spPr>
        <p:txBody>
          <a:bodyPr/>
          <a:lstStyle>
            <a:lvl1pPr marL="0" indent="0">
              <a:buNone/>
              <a:defRPr sz="2948">
                <a:solidFill>
                  <a:schemeClr val="tx1"/>
                </a:solidFill>
              </a:defRPr>
            </a:lvl1pPr>
            <a:lvl2pPr marL="561533" indent="0">
              <a:buNone/>
              <a:defRPr sz="2456">
                <a:solidFill>
                  <a:schemeClr val="tx1">
                    <a:tint val="75000"/>
                  </a:schemeClr>
                </a:solidFill>
              </a:defRPr>
            </a:lvl2pPr>
            <a:lvl3pPr marL="1123066" indent="0">
              <a:buNone/>
              <a:defRPr sz="2211">
                <a:solidFill>
                  <a:schemeClr val="tx1">
                    <a:tint val="75000"/>
                  </a:schemeClr>
                </a:solidFill>
              </a:defRPr>
            </a:lvl3pPr>
            <a:lvl4pPr marL="1684599" indent="0">
              <a:buNone/>
              <a:defRPr sz="1965">
                <a:solidFill>
                  <a:schemeClr val="tx1">
                    <a:tint val="75000"/>
                  </a:schemeClr>
                </a:solidFill>
              </a:defRPr>
            </a:lvl4pPr>
            <a:lvl5pPr marL="2246132" indent="0">
              <a:buNone/>
              <a:defRPr sz="1965">
                <a:solidFill>
                  <a:schemeClr val="tx1">
                    <a:tint val="75000"/>
                  </a:schemeClr>
                </a:solidFill>
              </a:defRPr>
            </a:lvl5pPr>
            <a:lvl6pPr marL="2807665" indent="0">
              <a:buNone/>
              <a:defRPr sz="1965">
                <a:solidFill>
                  <a:schemeClr val="tx1">
                    <a:tint val="75000"/>
                  </a:schemeClr>
                </a:solidFill>
              </a:defRPr>
            </a:lvl6pPr>
            <a:lvl7pPr marL="3369198" indent="0">
              <a:buNone/>
              <a:defRPr sz="1965">
                <a:solidFill>
                  <a:schemeClr val="tx1">
                    <a:tint val="75000"/>
                  </a:schemeClr>
                </a:solidFill>
              </a:defRPr>
            </a:lvl7pPr>
            <a:lvl8pPr marL="3930731" indent="0">
              <a:buNone/>
              <a:defRPr sz="1965">
                <a:solidFill>
                  <a:schemeClr val="tx1">
                    <a:tint val="75000"/>
                  </a:schemeClr>
                </a:solidFill>
              </a:defRPr>
            </a:lvl8pPr>
            <a:lvl9pPr marL="4492264" indent="0">
              <a:buNone/>
              <a:defRPr sz="196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CF1E-7AA4-4E42-A424-C38EAB80E525}" type="datetimeFigureOut">
              <a:rPr lang="zh-CN" altLang="en-US" smtClean="0"/>
              <a:t>2017/5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D229F9-B25F-451A-B756-CC9285415E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430003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242307"/>
            <a:ext cx="5181600" cy="5344491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242307"/>
            <a:ext cx="5181600" cy="5344491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CF1E-7AA4-4E42-A424-C38EAB80E525}" type="datetimeFigureOut">
              <a:rPr lang="zh-CN" altLang="en-US" smtClean="0"/>
              <a:t>2017/5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D229F9-B25F-451A-B756-CC9285415E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666977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48463"/>
            <a:ext cx="10515600" cy="1628110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064873"/>
            <a:ext cx="5157787" cy="1011962"/>
          </a:xfrm>
        </p:spPr>
        <p:txBody>
          <a:bodyPr anchor="b"/>
          <a:lstStyle>
            <a:lvl1pPr marL="0" indent="0">
              <a:buNone/>
              <a:defRPr sz="2948" b="1"/>
            </a:lvl1pPr>
            <a:lvl2pPr marL="561533" indent="0">
              <a:buNone/>
              <a:defRPr sz="2456" b="1"/>
            </a:lvl2pPr>
            <a:lvl3pPr marL="1123066" indent="0">
              <a:buNone/>
              <a:defRPr sz="2211" b="1"/>
            </a:lvl3pPr>
            <a:lvl4pPr marL="1684599" indent="0">
              <a:buNone/>
              <a:defRPr sz="1965" b="1"/>
            </a:lvl4pPr>
            <a:lvl5pPr marL="2246132" indent="0">
              <a:buNone/>
              <a:defRPr sz="1965" b="1"/>
            </a:lvl5pPr>
            <a:lvl6pPr marL="2807665" indent="0">
              <a:buNone/>
              <a:defRPr sz="1965" b="1"/>
            </a:lvl6pPr>
            <a:lvl7pPr marL="3369198" indent="0">
              <a:buNone/>
              <a:defRPr sz="1965" b="1"/>
            </a:lvl7pPr>
            <a:lvl8pPr marL="3930731" indent="0">
              <a:buNone/>
              <a:defRPr sz="1965" b="1"/>
            </a:lvl8pPr>
            <a:lvl9pPr marL="4492264" indent="0">
              <a:buNone/>
              <a:defRPr sz="1965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076835"/>
            <a:ext cx="5157787" cy="4525561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064873"/>
            <a:ext cx="5183188" cy="1011962"/>
          </a:xfrm>
        </p:spPr>
        <p:txBody>
          <a:bodyPr anchor="b"/>
          <a:lstStyle>
            <a:lvl1pPr marL="0" indent="0">
              <a:buNone/>
              <a:defRPr sz="2948" b="1"/>
            </a:lvl1pPr>
            <a:lvl2pPr marL="561533" indent="0">
              <a:buNone/>
              <a:defRPr sz="2456" b="1"/>
            </a:lvl2pPr>
            <a:lvl3pPr marL="1123066" indent="0">
              <a:buNone/>
              <a:defRPr sz="2211" b="1"/>
            </a:lvl3pPr>
            <a:lvl4pPr marL="1684599" indent="0">
              <a:buNone/>
              <a:defRPr sz="1965" b="1"/>
            </a:lvl4pPr>
            <a:lvl5pPr marL="2246132" indent="0">
              <a:buNone/>
              <a:defRPr sz="1965" b="1"/>
            </a:lvl5pPr>
            <a:lvl6pPr marL="2807665" indent="0">
              <a:buNone/>
              <a:defRPr sz="1965" b="1"/>
            </a:lvl6pPr>
            <a:lvl7pPr marL="3369198" indent="0">
              <a:buNone/>
              <a:defRPr sz="1965" b="1"/>
            </a:lvl7pPr>
            <a:lvl8pPr marL="3930731" indent="0">
              <a:buNone/>
              <a:defRPr sz="1965" b="1"/>
            </a:lvl8pPr>
            <a:lvl9pPr marL="4492264" indent="0">
              <a:buNone/>
              <a:defRPr sz="1965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076835"/>
            <a:ext cx="5183188" cy="4525561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CF1E-7AA4-4E42-A424-C38EAB80E525}" type="datetimeFigureOut">
              <a:rPr lang="zh-CN" altLang="en-US" smtClean="0"/>
              <a:t>2017/5/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D229F9-B25F-451A-B756-CC9285415E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74757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CF1E-7AA4-4E42-A424-C38EAB80E525}" type="datetimeFigureOut">
              <a:rPr lang="zh-CN" altLang="en-US" smtClean="0"/>
              <a:t>2017/5/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D229F9-B25F-451A-B756-CC9285415E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53031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CF1E-7AA4-4E42-A424-C38EAB80E525}" type="datetimeFigureOut">
              <a:rPr lang="zh-CN" altLang="en-US" smtClean="0"/>
              <a:t>2017/5/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D229F9-B25F-451A-B756-CC9285415E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021933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61552"/>
            <a:ext cx="3932237" cy="1965431"/>
          </a:xfrm>
        </p:spPr>
        <p:txBody>
          <a:bodyPr anchor="b"/>
          <a:lstStyle>
            <a:lvl1pPr>
              <a:defRPr sz="393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212797"/>
            <a:ext cx="6172200" cy="5985985"/>
          </a:xfrm>
        </p:spPr>
        <p:txBody>
          <a:bodyPr/>
          <a:lstStyle>
            <a:lvl1pPr>
              <a:defRPr sz="3930"/>
            </a:lvl1pPr>
            <a:lvl2pPr>
              <a:defRPr sz="3439"/>
            </a:lvl2pPr>
            <a:lvl3pPr>
              <a:defRPr sz="2948"/>
            </a:lvl3pPr>
            <a:lvl4pPr>
              <a:defRPr sz="2456"/>
            </a:lvl4pPr>
            <a:lvl5pPr>
              <a:defRPr sz="2456"/>
            </a:lvl5pPr>
            <a:lvl6pPr>
              <a:defRPr sz="2456"/>
            </a:lvl6pPr>
            <a:lvl7pPr>
              <a:defRPr sz="2456"/>
            </a:lvl7pPr>
            <a:lvl8pPr>
              <a:defRPr sz="2456"/>
            </a:lvl8pPr>
            <a:lvl9pPr>
              <a:defRPr sz="2456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526982"/>
            <a:ext cx="3932237" cy="4681548"/>
          </a:xfrm>
        </p:spPr>
        <p:txBody>
          <a:bodyPr/>
          <a:lstStyle>
            <a:lvl1pPr marL="0" indent="0">
              <a:buNone/>
              <a:defRPr sz="1965"/>
            </a:lvl1pPr>
            <a:lvl2pPr marL="561533" indent="0">
              <a:buNone/>
              <a:defRPr sz="1719"/>
            </a:lvl2pPr>
            <a:lvl3pPr marL="1123066" indent="0">
              <a:buNone/>
              <a:defRPr sz="1474"/>
            </a:lvl3pPr>
            <a:lvl4pPr marL="1684599" indent="0">
              <a:buNone/>
              <a:defRPr sz="1228"/>
            </a:lvl4pPr>
            <a:lvl5pPr marL="2246132" indent="0">
              <a:buNone/>
              <a:defRPr sz="1228"/>
            </a:lvl5pPr>
            <a:lvl6pPr marL="2807665" indent="0">
              <a:buNone/>
              <a:defRPr sz="1228"/>
            </a:lvl6pPr>
            <a:lvl7pPr marL="3369198" indent="0">
              <a:buNone/>
              <a:defRPr sz="1228"/>
            </a:lvl7pPr>
            <a:lvl8pPr marL="3930731" indent="0">
              <a:buNone/>
              <a:defRPr sz="1228"/>
            </a:lvl8pPr>
            <a:lvl9pPr marL="4492264" indent="0">
              <a:buNone/>
              <a:defRPr sz="1228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CF1E-7AA4-4E42-A424-C38EAB80E525}" type="datetimeFigureOut">
              <a:rPr lang="zh-CN" altLang="en-US" smtClean="0"/>
              <a:t>2017/5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D229F9-B25F-451A-B756-CC9285415E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01125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61552"/>
            <a:ext cx="3932237" cy="1965431"/>
          </a:xfrm>
        </p:spPr>
        <p:txBody>
          <a:bodyPr anchor="b"/>
          <a:lstStyle>
            <a:lvl1pPr>
              <a:defRPr sz="393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212797"/>
            <a:ext cx="6172200" cy="5985985"/>
          </a:xfrm>
        </p:spPr>
        <p:txBody>
          <a:bodyPr anchor="t"/>
          <a:lstStyle>
            <a:lvl1pPr marL="0" indent="0">
              <a:buNone/>
              <a:defRPr sz="3930"/>
            </a:lvl1pPr>
            <a:lvl2pPr marL="561533" indent="0">
              <a:buNone/>
              <a:defRPr sz="3439"/>
            </a:lvl2pPr>
            <a:lvl3pPr marL="1123066" indent="0">
              <a:buNone/>
              <a:defRPr sz="2948"/>
            </a:lvl3pPr>
            <a:lvl4pPr marL="1684599" indent="0">
              <a:buNone/>
              <a:defRPr sz="2456"/>
            </a:lvl4pPr>
            <a:lvl5pPr marL="2246132" indent="0">
              <a:buNone/>
              <a:defRPr sz="2456"/>
            </a:lvl5pPr>
            <a:lvl6pPr marL="2807665" indent="0">
              <a:buNone/>
              <a:defRPr sz="2456"/>
            </a:lvl6pPr>
            <a:lvl7pPr marL="3369198" indent="0">
              <a:buNone/>
              <a:defRPr sz="2456"/>
            </a:lvl7pPr>
            <a:lvl8pPr marL="3930731" indent="0">
              <a:buNone/>
              <a:defRPr sz="2456"/>
            </a:lvl8pPr>
            <a:lvl9pPr marL="4492264" indent="0">
              <a:buNone/>
              <a:defRPr sz="2456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526982"/>
            <a:ext cx="3932237" cy="4681548"/>
          </a:xfrm>
        </p:spPr>
        <p:txBody>
          <a:bodyPr/>
          <a:lstStyle>
            <a:lvl1pPr marL="0" indent="0">
              <a:buNone/>
              <a:defRPr sz="1965"/>
            </a:lvl1pPr>
            <a:lvl2pPr marL="561533" indent="0">
              <a:buNone/>
              <a:defRPr sz="1719"/>
            </a:lvl2pPr>
            <a:lvl3pPr marL="1123066" indent="0">
              <a:buNone/>
              <a:defRPr sz="1474"/>
            </a:lvl3pPr>
            <a:lvl4pPr marL="1684599" indent="0">
              <a:buNone/>
              <a:defRPr sz="1228"/>
            </a:lvl4pPr>
            <a:lvl5pPr marL="2246132" indent="0">
              <a:buNone/>
              <a:defRPr sz="1228"/>
            </a:lvl5pPr>
            <a:lvl6pPr marL="2807665" indent="0">
              <a:buNone/>
              <a:defRPr sz="1228"/>
            </a:lvl6pPr>
            <a:lvl7pPr marL="3369198" indent="0">
              <a:buNone/>
              <a:defRPr sz="1228"/>
            </a:lvl7pPr>
            <a:lvl8pPr marL="3930731" indent="0">
              <a:buNone/>
              <a:defRPr sz="1228"/>
            </a:lvl8pPr>
            <a:lvl9pPr marL="4492264" indent="0">
              <a:buNone/>
              <a:defRPr sz="1228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CF1E-7AA4-4E42-A424-C38EAB80E525}" type="datetimeFigureOut">
              <a:rPr lang="zh-CN" altLang="en-US" smtClean="0"/>
              <a:t>2017/5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D229F9-B25F-451A-B756-CC9285415E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12312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48463"/>
            <a:ext cx="10515600" cy="162811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242307"/>
            <a:ext cx="10515600" cy="53444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7807130"/>
            <a:ext cx="2743200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7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B4CF1E-7AA4-4E42-A424-C38EAB80E525}" type="datetimeFigureOut">
              <a:rPr lang="zh-CN" altLang="en-US" smtClean="0"/>
              <a:t>2017/5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7807130"/>
            <a:ext cx="4114800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7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7807130"/>
            <a:ext cx="2743200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7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D229F9-B25F-451A-B756-CC9285415E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363237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123066" rtl="0" eaLnBrk="1" latinLnBrk="0" hangingPunct="1">
        <a:lnSpc>
          <a:spcPct val="90000"/>
        </a:lnSpc>
        <a:spcBef>
          <a:spcPct val="0"/>
        </a:spcBef>
        <a:buNone/>
        <a:defRPr sz="540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80767" indent="-280767" algn="l" defTabSz="1123066" rtl="0" eaLnBrk="1" latinLnBrk="0" hangingPunct="1">
        <a:lnSpc>
          <a:spcPct val="90000"/>
        </a:lnSpc>
        <a:spcBef>
          <a:spcPts val="1228"/>
        </a:spcBef>
        <a:buFont typeface="Arial" panose="020B0604020202020204" pitchFamily="34" charset="0"/>
        <a:buChar char="•"/>
        <a:defRPr sz="3439" kern="1200">
          <a:solidFill>
            <a:schemeClr val="tx1"/>
          </a:solidFill>
          <a:latin typeface="+mn-lt"/>
          <a:ea typeface="+mn-ea"/>
          <a:cs typeface="+mn-cs"/>
        </a:defRPr>
      </a:lvl1pPr>
      <a:lvl2pPr marL="842300" indent="-280767" algn="l" defTabSz="1123066" rtl="0" eaLnBrk="1" latinLnBrk="0" hangingPunct="1">
        <a:lnSpc>
          <a:spcPct val="90000"/>
        </a:lnSpc>
        <a:spcBef>
          <a:spcPts val="614"/>
        </a:spcBef>
        <a:buFont typeface="Arial" panose="020B0604020202020204" pitchFamily="34" charset="0"/>
        <a:buChar char="•"/>
        <a:defRPr sz="2948" kern="1200">
          <a:solidFill>
            <a:schemeClr val="tx1"/>
          </a:solidFill>
          <a:latin typeface="+mn-lt"/>
          <a:ea typeface="+mn-ea"/>
          <a:cs typeface="+mn-cs"/>
        </a:defRPr>
      </a:lvl2pPr>
      <a:lvl3pPr marL="1403833" indent="-280767" algn="l" defTabSz="1123066" rtl="0" eaLnBrk="1" latinLnBrk="0" hangingPunct="1">
        <a:lnSpc>
          <a:spcPct val="90000"/>
        </a:lnSpc>
        <a:spcBef>
          <a:spcPts val="614"/>
        </a:spcBef>
        <a:buFont typeface="Arial" panose="020B0604020202020204" pitchFamily="34" charset="0"/>
        <a:buChar char="•"/>
        <a:defRPr sz="2456" kern="1200">
          <a:solidFill>
            <a:schemeClr val="tx1"/>
          </a:solidFill>
          <a:latin typeface="+mn-lt"/>
          <a:ea typeface="+mn-ea"/>
          <a:cs typeface="+mn-cs"/>
        </a:defRPr>
      </a:lvl3pPr>
      <a:lvl4pPr marL="1965366" indent="-280767" algn="l" defTabSz="1123066" rtl="0" eaLnBrk="1" latinLnBrk="0" hangingPunct="1">
        <a:lnSpc>
          <a:spcPct val="90000"/>
        </a:lnSpc>
        <a:spcBef>
          <a:spcPts val="614"/>
        </a:spcBef>
        <a:buFont typeface="Arial" panose="020B0604020202020204" pitchFamily="34" charset="0"/>
        <a:buChar char="•"/>
        <a:defRPr sz="2211" kern="1200">
          <a:solidFill>
            <a:schemeClr val="tx1"/>
          </a:solidFill>
          <a:latin typeface="+mn-lt"/>
          <a:ea typeface="+mn-ea"/>
          <a:cs typeface="+mn-cs"/>
        </a:defRPr>
      </a:lvl4pPr>
      <a:lvl5pPr marL="2526899" indent="-280767" algn="l" defTabSz="1123066" rtl="0" eaLnBrk="1" latinLnBrk="0" hangingPunct="1">
        <a:lnSpc>
          <a:spcPct val="90000"/>
        </a:lnSpc>
        <a:spcBef>
          <a:spcPts val="614"/>
        </a:spcBef>
        <a:buFont typeface="Arial" panose="020B0604020202020204" pitchFamily="34" charset="0"/>
        <a:buChar char="•"/>
        <a:defRPr sz="2211" kern="1200">
          <a:solidFill>
            <a:schemeClr val="tx1"/>
          </a:solidFill>
          <a:latin typeface="+mn-lt"/>
          <a:ea typeface="+mn-ea"/>
          <a:cs typeface="+mn-cs"/>
        </a:defRPr>
      </a:lvl5pPr>
      <a:lvl6pPr marL="3088432" indent="-280767" algn="l" defTabSz="1123066" rtl="0" eaLnBrk="1" latinLnBrk="0" hangingPunct="1">
        <a:lnSpc>
          <a:spcPct val="90000"/>
        </a:lnSpc>
        <a:spcBef>
          <a:spcPts val="614"/>
        </a:spcBef>
        <a:buFont typeface="Arial" panose="020B0604020202020204" pitchFamily="34" charset="0"/>
        <a:buChar char="•"/>
        <a:defRPr sz="2211" kern="1200">
          <a:solidFill>
            <a:schemeClr val="tx1"/>
          </a:solidFill>
          <a:latin typeface="+mn-lt"/>
          <a:ea typeface="+mn-ea"/>
          <a:cs typeface="+mn-cs"/>
        </a:defRPr>
      </a:lvl6pPr>
      <a:lvl7pPr marL="3649965" indent="-280767" algn="l" defTabSz="1123066" rtl="0" eaLnBrk="1" latinLnBrk="0" hangingPunct="1">
        <a:lnSpc>
          <a:spcPct val="90000"/>
        </a:lnSpc>
        <a:spcBef>
          <a:spcPts val="614"/>
        </a:spcBef>
        <a:buFont typeface="Arial" panose="020B0604020202020204" pitchFamily="34" charset="0"/>
        <a:buChar char="•"/>
        <a:defRPr sz="2211" kern="1200">
          <a:solidFill>
            <a:schemeClr val="tx1"/>
          </a:solidFill>
          <a:latin typeface="+mn-lt"/>
          <a:ea typeface="+mn-ea"/>
          <a:cs typeface="+mn-cs"/>
        </a:defRPr>
      </a:lvl7pPr>
      <a:lvl8pPr marL="4211498" indent="-280767" algn="l" defTabSz="1123066" rtl="0" eaLnBrk="1" latinLnBrk="0" hangingPunct="1">
        <a:lnSpc>
          <a:spcPct val="90000"/>
        </a:lnSpc>
        <a:spcBef>
          <a:spcPts val="614"/>
        </a:spcBef>
        <a:buFont typeface="Arial" panose="020B0604020202020204" pitchFamily="34" charset="0"/>
        <a:buChar char="•"/>
        <a:defRPr sz="2211" kern="1200">
          <a:solidFill>
            <a:schemeClr val="tx1"/>
          </a:solidFill>
          <a:latin typeface="+mn-lt"/>
          <a:ea typeface="+mn-ea"/>
          <a:cs typeface="+mn-cs"/>
        </a:defRPr>
      </a:lvl8pPr>
      <a:lvl9pPr marL="4773031" indent="-280767" algn="l" defTabSz="1123066" rtl="0" eaLnBrk="1" latinLnBrk="0" hangingPunct="1">
        <a:lnSpc>
          <a:spcPct val="90000"/>
        </a:lnSpc>
        <a:spcBef>
          <a:spcPts val="614"/>
        </a:spcBef>
        <a:buFont typeface="Arial" panose="020B0604020202020204" pitchFamily="34" charset="0"/>
        <a:buChar char="•"/>
        <a:defRPr sz="221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23066" rtl="0" eaLnBrk="1" latinLnBrk="0" hangingPunct="1">
        <a:defRPr sz="2211" kern="1200">
          <a:solidFill>
            <a:schemeClr val="tx1"/>
          </a:solidFill>
          <a:latin typeface="+mn-lt"/>
          <a:ea typeface="+mn-ea"/>
          <a:cs typeface="+mn-cs"/>
        </a:defRPr>
      </a:lvl1pPr>
      <a:lvl2pPr marL="561533" algn="l" defTabSz="1123066" rtl="0" eaLnBrk="1" latinLnBrk="0" hangingPunct="1">
        <a:defRPr sz="2211" kern="1200">
          <a:solidFill>
            <a:schemeClr val="tx1"/>
          </a:solidFill>
          <a:latin typeface="+mn-lt"/>
          <a:ea typeface="+mn-ea"/>
          <a:cs typeface="+mn-cs"/>
        </a:defRPr>
      </a:lvl2pPr>
      <a:lvl3pPr marL="1123066" algn="l" defTabSz="1123066" rtl="0" eaLnBrk="1" latinLnBrk="0" hangingPunct="1">
        <a:defRPr sz="2211" kern="1200">
          <a:solidFill>
            <a:schemeClr val="tx1"/>
          </a:solidFill>
          <a:latin typeface="+mn-lt"/>
          <a:ea typeface="+mn-ea"/>
          <a:cs typeface="+mn-cs"/>
        </a:defRPr>
      </a:lvl3pPr>
      <a:lvl4pPr marL="1684599" algn="l" defTabSz="1123066" rtl="0" eaLnBrk="1" latinLnBrk="0" hangingPunct="1">
        <a:defRPr sz="2211" kern="1200">
          <a:solidFill>
            <a:schemeClr val="tx1"/>
          </a:solidFill>
          <a:latin typeface="+mn-lt"/>
          <a:ea typeface="+mn-ea"/>
          <a:cs typeface="+mn-cs"/>
        </a:defRPr>
      </a:lvl4pPr>
      <a:lvl5pPr marL="2246132" algn="l" defTabSz="1123066" rtl="0" eaLnBrk="1" latinLnBrk="0" hangingPunct="1">
        <a:defRPr sz="2211" kern="1200">
          <a:solidFill>
            <a:schemeClr val="tx1"/>
          </a:solidFill>
          <a:latin typeface="+mn-lt"/>
          <a:ea typeface="+mn-ea"/>
          <a:cs typeface="+mn-cs"/>
        </a:defRPr>
      </a:lvl5pPr>
      <a:lvl6pPr marL="2807665" algn="l" defTabSz="1123066" rtl="0" eaLnBrk="1" latinLnBrk="0" hangingPunct="1">
        <a:defRPr sz="2211" kern="1200">
          <a:solidFill>
            <a:schemeClr val="tx1"/>
          </a:solidFill>
          <a:latin typeface="+mn-lt"/>
          <a:ea typeface="+mn-ea"/>
          <a:cs typeface="+mn-cs"/>
        </a:defRPr>
      </a:lvl6pPr>
      <a:lvl7pPr marL="3369198" algn="l" defTabSz="1123066" rtl="0" eaLnBrk="1" latinLnBrk="0" hangingPunct="1">
        <a:defRPr sz="2211" kern="1200">
          <a:solidFill>
            <a:schemeClr val="tx1"/>
          </a:solidFill>
          <a:latin typeface="+mn-lt"/>
          <a:ea typeface="+mn-ea"/>
          <a:cs typeface="+mn-cs"/>
        </a:defRPr>
      </a:lvl7pPr>
      <a:lvl8pPr marL="3930731" algn="l" defTabSz="1123066" rtl="0" eaLnBrk="1" latinLnBrk="0" hangingPunct="1">
        <a:defRPr sz="2211" kern="1200">
          <a:solidFill>
            <a:schemeClr val="tx1"/>
          </a:solidFill>
          <a:latin typeface="+mn-lt"/>
          <a:ea typeface="+mn-ea"/>
          <a:cs typeface="+mn-cs"/>
        </a:defRPr>
      </a:lvl8pPr>
      <a:lvl9pPr marL="4492264" algn="l" defTabSz="1123066" rtl="0" eaLnBrk="1" latinLnBrk="0" hangingPunct="1">
        <a:defRPr sz="221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>
          <a:xfrm>
            <a:off x="1006929" y="5322038"/>
            <a:ext cx="9982199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ltiple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ignment of the DNA sequences of </a:t>
            </a:r>
            <a:r>
              <a:rPr lang="en-US" altLang="zh-CN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id4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mplicons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rom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Renan, </a:t>
            </a:r>
            <a:r>
              <a:rPr lang="en-US" altLang="zh-CN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angdon and G1812, as well as Renan </a:t>
            </a:r>
            <a:r>
              <a:rPr lang="en-US" altLang="zh-CN" i="1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Bx</a:t>
            </a:r>
            <a:r>
              <a:rPr lang="en-US" altLang="zh-CN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zh-CN" i="1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Dx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Binding sites of the primers were indicated by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rows.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difference of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mplicons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mong them was indicated by dashed lines. Length (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each sequence was indicated at the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′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d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zh-CN" altLang="zh-CN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8" name="组合 7"/>
          <p:cNvGrpSpPr/>
          <p:nvPr/>
        </p:nvGrpSpPr>
        <p:grpSpPr>
          <a:xfrm>
            <a:off x="633955" y="1253683"/>
            <a:ext cx="10754901" cy="2498510"/>
            <a:chOff x="633955" y="1253683"/>
            <a:chExt cx="10754901" cy="2498510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33955" y="1303923"/>
              <a:ext cx="10754901" cy="2448270"/>
            </a:xfrm>
            <a:prstGeom prst="rect">
              <a:avLst/>
            </a:prstGeom>
          </p:spPr>
        </p:pic>
        <p:cxnSp>
          <p:nvCxnSpPr>
            <p:cNvPr id="5" name="直接箭头连接符 4"/>
            <p:cNvCxnSpPr/>
            <p:nvPr/>
          </p:nvCxnSpPr>
          <p:spPr>
            <a:xfrm>
              <a:off x="1850940" y="1253683"/>
              <a:ext cx="1728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直接箭头连接符 5"/>
            <p:cNvCxnSpPr/>
            <p:nvPr/>
          </p:nvCxnSpPr>
          <p:spPr>
            <a:xfrm flipH="1">
              <a:off x="6356344" y="2481759"/>
              <a:ext cx="2160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2599050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2</TotalTime>
  <Words>64</Words>
  <Application>Microsoft Office PowerPoint</Application>
  <PresentationFormat>自定义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dzy</dc:creator>
  <cp:lastModifiedBy>dzy</cp:lastModifiedBy>
  <cp:revision>17</cp:revision>
  <dcterms:created xsi:type="dcterms:W3CDTF">2015-08-20T11:18:46Z</dcterms:created>
  <dcterms:modified xsi:type="dcterms:W3CDTF">2017-05-09T07:21:51Z</dcterms:modified>
</cp:coreProperties>
</file>